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82" r:id="rId2"/>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6014" autoAdjust="0"/>
    <p:restoredTop sz="93447" autoAdjust="0"/>
  </p:normalViewPr>
  <p:slideViewPr>
    <p:cSldViewPr snapToGrid="0">
      <p:cViewPr varScale="1">
        <p:scale>
          <a:sx n="107" d="100"/>
          <a:sy n="107" d="100"/>
        </p:scale>
        <p:origin x="120" y="1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Quann, Karen" userId="94a201d7-e4f0-4194-8931-e17bc8cf8cf2" providerId="ADAL" clId="{9E3EB9D4-51F3-4D87-BBC2-786AEBA6296E}"/>
    <pc:docChg chg="modSld">
      <pc:chgData name="Quann, Karen" userId="94a201d7-e4f0-4194-8931-e17bc8cf8cf2" providerId="ADAL" clId="{9E3EB9D4-51F3-4D87-BBC2-786AEBA6296E}" dt="2025-10-21T17:10:27.908" v="23"/>
      <pc:docMkLst>
        <pc:docMk/>
      </pc:docMkLst>
      <pc:sldChg chg="delSp modSp mod">
        <pc:chgData name="Quann, Karen" userId="94a201d7-e4f0-4194-8931-e17bc8cf8cf2" providerId="ADAL" clId="{9E3EB9D4-51F3-4D87-BBC2-786AEBA6296E}" dt="2025-10-21T17:10:27.908" v="23"/>
        <pc:sldMkLst>
          <pc:docMk/>
          <pc:sldMk cId="3621451286" sldId="282"/>
        </pc:sldMkLst>
        <pc:spChg chg="del mod">
          <ac:chgData name="Quann, Karen" userId="94a201d7-e4f0-4194-8931-e17bc8cf8cf2" providerId="ADAL" clId="{9E3EB9D4-51F3-4D87-BBC2-786AEBA6296E}" dt="2025-10-21T17:10:27.908" v="23"/>
          <ac:spMkLst>
            <pc:docMk/>
            <pc:sldMk cId="3621451286" sldId="282"/>
            <ac:spMk id="3" creationId="{3E527F86-E4EB-8927-9034-476343A517D2}"/>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A5878891-3B70-4B94-BAEE-88FEB18586E5}" type="datetimeFigureOut">
              <a:rPr lang="en-US" smtClean="0"/>
              <a:t>10/21/2025</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5897DE3F-8F04-476B-AF8E-D0D1D2CF36AF}" type="slidenum">
              <a:rPr lang="en-US" smtClean="0"/>
              <a:t>‹#›</a:t>
            </a:fld>
            <a:endParaRPr lang="en-US"/>
          </a:p>
        </p:txBody>
      </p:sp>
    </p:spTree>
    <p:extLst>
      <p:ext uri="{BB962C8B-B14F-4D97-AF65-F5344CB8AC3E}">
        <p14:creationId xmlns:p14="http://schemas.microsoft.com/office/powerpoint/2010/main" val="3329376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897DE3F-8F04-476B-AF8E-D0D1D2CF36AF}" type="slidenum">
              <a:rPr lang="en-US" smtClean="0"/>
              <a:t>1</a:t>
            </a:fld>
            <a:endParaRPr lang="en-US"/>
          </a:p>
        </p:txBody>
      </p:sp>
    </p:spTree>
    <p:extLst>
      <p:ext uri="{BB962C8B-B14F-4D97-AF65-F5344CB8AC3E}">
        <p14:creationId xmlns:p14="http://schemas.microsoft.com/office/powerpoint/2010/main" val="24914955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DECF64-62E6-4B8E-90D5-84029C0D69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FC55DB-270A-FE06-C0C2-8C3B7960E0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36E5E1-EFE0-D916-EE58-848BFE985C13}"/>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7C624415-F5A9-5098-5E2E-9C05872486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45B319-3B47-4B86-1939-2395AC0E0B5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606070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48B98-5F78-5FAE-F487-932D8CDB556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050F19-B690-1C98-4C97-C2EB701659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7D955-E84D-DA92-71E0-19983DE7EE3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26EE7442-0FA0-0662-4880-EB70B5A38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A60A8C-DACC-C25D-EA31-2286374737F2}"/>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991473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FAA582-80EA-8FFE-6717-8F7660FD22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06AB09-1D1B-598A-3196-87DE1F9B81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1D5950-191C-D2E6-3974-A35C46151C9A}"/>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FFE24EE5-9452-84DF-1A7F-3D2E1C52CE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4FCC4B-8E7D-2B5D-0791-B950B76224E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83699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103AE-2CA8-D316-AFE5-E63ABEA098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C24A61-629B-67A4-921D-8E595D3372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1DC599-085D-F352-6523-1CE8CB325E87}"/>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E2056BCE-8FDD-DC7C-BFA2-646FCFD7F6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0E68B1-7026-6D9A-AA6F-86D5A2244AC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84700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159DE-46C7-7112-D8F4-AC0846F4D4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751615-850B-8EE3-CD07-A41BCC96B0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6D6D35-6EEE-76CB-A7B3-9393C6285B9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AEE1BD30-B32D-92E3-8943-51DD5C0056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3268-9725-9EEB-4396-3DC7FE27B90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87206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EA0BF-849F-9564-DDCD-9D6E2F52E8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B608DA-F013-88F9-DECC-12F3D99742B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1B9CD44-76E8-EB8B-4F78-D717428AF9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A4DA9-3BC5-6799-6BA0-C4C1991711AD}"/>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7050E6D9-1A18-C6B4-92F5-CFF5A6A408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9BB7A-3135-2BF6-6401-D24789835F98}"/>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42824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FAC7F-C16F-D8C4-3D2E-AD085291B3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FF2890-2C17-37FD-0A84-F3892166DD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05EA2C-667E-3AB7-E26B-8A78C667B4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F41096-C25D-2831-01D7-2D3B934545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951FEE-E9E0-6A8E-CE16-01F17AD753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5F7DA7-B82C-D8DB-4CB6-A2EBB76DAB39}"/>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8" name="Footer Placeholder 7">
            <a:extLst>
              <a:ext uri="{FF2B5EF4-FFF2-40B4-BE49-F238E27FC236}">
                <a16:creationId xmlns:a16="http://schemas.microsoft.com/office/drawing/2014/main" id="{04914E22-4792-AF32-96EE-BA1F85350A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12D419-4CC5-FE70-6BE4-A530667D1FE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599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6F74C-1488-E29C-0EF7-29815B736E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1B1ADC-5E07-A38D-9B4D-54BDEEA376C2}"/>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4" name="Footer Placeholder 3">
            <a:extLst>
              <a:ext uri="{FF2B5EF4-FFF2-40B4-BE49-F238E27FC236}">
                <a16:creationId xmlns:a16="http://schemas.microsoft.com/office/drawing/2014/main" id="{FFD3A60B-1623-0F7E-17FA-23C909281C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73969C3-F1A5-90A5-D54E-E6258A2D44DD}"/>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9066122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1E7637-6E7A-283C-6283-60359DF8E83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3" name="Footer Placeholder 2">
            <a:extLst>
              <a:ext uri="{FF2B5EF4-FFF2-40B4-BE49-F238E27FC236}">
                <a16:creationId xmlns:a16="http://schemas.microsoft.com/office/drawing/2014/main" id="{E7E4978E-B117-9941-29EC-A70E0FA980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FD7E27-B98F-6776-573A-EBACEC9A485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50792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DCCCB-1A48-3A52-BAE1-BFED42D545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934DA0-DFB0-DE2B-9DD5-A6E08348AD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925438A-98D3-6F12-5556-FD99DD4489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FD4AED-5D58-CA1B-FD3F-15506906C2F0}"/>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F79CB4F1-064F-7EE5-ECD7-3AF181820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6C0817-EA96-463A-7FC5-0238C772BE9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812498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5C869-05BF-9F9A-18D3-0662AB90A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CA6735-F013-975D-91C3-36205A9383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843637-448B-0412-ED75-BFAC61BA7F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F5FAF-7C11-BCAF-C5F7-9DB8DF122AA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43637007-F46F-052B-F5EC-2C05A50B9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9C9CED-02A8-286D-37DD-8F866DB2316E}"/>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34831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47AEBF-16CF-0A62-F011-6A11A4E998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01EB9A-1BFA-5855-3D70-BBE95E170F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F12A36-4D3F-6E80-E41F-79314E920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85249328-9A8E-A056-517B-F9FD5B9D8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A80532B-B214-6D1B-94CE-81305ED7AB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881D2E-E029-4622-A508-9B9C13E12A34}" type="slidenum">
              <a:rPr lang="en-US" smtClean="0"/>
              <a:t>‹#›</a:t>
            </a:fld>
            <a:endParaRPr lang="en-US"/>
          </a:p>
        </p:txBody>
      </p:sp>
    </p:spTree>
    <p:extLst>
      <p:ext uri="{BB962C8B-B14F-4D97-AF65-F5344CB8AC3E}">
        <p14:creationId xmlns:p14="http://schemas.microsoft.com/office/powerpoint/2010/main" val="1010233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screenshot of a data graph&#10;&#10;Description automatically generated">
            <a:extLst>
              <a:ext uri="{FF2B5EF4-FFF2-40B4-BE49-F238E27FC236}">
                <a16:creationId xmlns:a16="http://schemas.microsoft.com/office/drawing/2014/main" id="{89E4E6AA-8960-19E8-ECFB-42610CD14788}"/>
              </a:ext>
            </a:extLst>
          </p:cNvPr>
          <p:cNvPicPr>
            <a:picLocks noChangeAspect="1"/>
          </p:cNvPicPr>
          <p:nvPr/>
        </p:nvPicPr>
        <p:blipFill rotWithShape="1">
          <a:blip r:embed="rId3"/>
          <a:srcRect b="7841"/>
          <a:stretch/>
        </p:blipFill>
        <p:spPr>
          <a:xfrm>
            <a:off x="1954530" y="379485"/>
            <a:ext cx="6617969" cy="6099029"/>
          </a:xfrm>
          <a:prstGeom prst="rect">
            <a:avLst/>
          </a:prstGeom>
        </p:spPr>
      </p:pic>
      <p:pic>
        <p:nvPicPr>
          <p:cNvPr id="7" name="Picture 6" descr="A chart of different colored bars&#10;&#10;Description automatically generated">
            <a:extLst>
              <a:ext uri="{FF2B5EF4-FFF2-40B4-BE49-F238E27FC236}">
                <a16:creationId xmlns:a16="http://schemas.microsoft.com/office/drawing/2014/main" id="{46EF7675-0AD3-FAD1-4D39-800DDA46AC0D}"/>
              </a:ext>
            </a:extLst>
          </p:cNvPr>
          <p:cNvPicPr>
            <a:picLocks noChangeAspect="1"/>
          </p:cNvPicPr>
          <p:nvPr/>
        </p:nvPicPr>
        <p:blipFill rotWithShape="1">
          <a:blip r:embed="rId4"/>
          <a:srcRect l="82638" t="30092" r="5444" b="44440"/>
          <a:stretch/>
        </p:blipFill>
        <p:spPr>
          <a:xfrm>
            <a:off x="8208350" y="2770201"/>
            <a:ext cx="1794715" cy="2013984"/>
          </a:xfrm>
          <a:prstGeom prst="rect">
            <a:avLst/>
          </a:prstGeom>
        </p:spPr>
      </p:pic>
      <p:sp>
        <p:nvSpPr>
          <p:cNvPr id="2" name="TextBox 1">
            <a:extLst>
              <a:ext uri="{FF2B5EF4-FFF2-40B4-BE49-F238E27FC236}">
                <a16:creationId xmlns:a16="http://schemas.microsoft.com/office/drawing/2014/main" id="{727F6014-B6E0-C8A2-67EB-7C2B0BA0F0B7}"/>
              </a:ext>
            </a:extLst>
          </p:cNvPr>
          <p:cNvSpPr txBox="1"/>
          <p:nvPr/>
        </p:nvSpPr>
        <p:spPr>
          <a:xfrm>
            <a:off x="8208350" y="187052"/>
            <a:ext cx="342900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Normalized Expression Level</a:t>
            </a:r>
          </a:p>
        </p:txBody>
      </p:sp>
      <p:sp>
        <p:nvSpPr>
          <p:cNvPr id="4" name="TextBox 3">
            <a:extLst>
              <a:ext uri="{FF2B5EF4-FFF2-40B4-BE49-F238E27FC236}">
                <a16:creationId xmlns:a16="http://schemas.microsoft.com/office/drawing/2014/main" id="{46A738CA-E04E-9C41-055A-46D5743E2A1B}"/>
              </a:ext>
            </a:extLst>
          </p:cNvPr>
          <p:cNvSpPr txBox="1"/>
          <p:nvPr/>
        </p:nvSpPr>
        <p:spPr>
          <a:xfrm>
            <a:off x="259976" y="6478514"/>
            <a:ext cx="11833412" cy="338554"/>
          </a:xfrm>
          <a:prstGeom prst="rect">
            <a:avLst/>
          </a:prstGeom>
          <a:noFill/>
        </p:spPr>
        <p:txBody>
          <a:bodyPr wrap="square" rtlCol="0">
            <a:spAutoFit/>
          </a:bodyPr>
          <a:lstStyle/>
          <a:p>
            <a:r>
              <a:rPr lang="en-US" sz="800" b="1" kern="0" dirty="0">
                <a:effectLst/>
                <a:latin typeface="Arial" panose="020B0604020202020204" pitchFamily="34" charset="0"/>
                <a:ea typeface="SimSun" panose="02010600030101010101" pitchFamily="2" charset="-122"/>
              </a:rPr>
              <a:t>Supplementary Figure 3.  Summary of gene signature results from the </a:t>
            </a:r>
            <a:r>
              <a:rPr lang="en-US" sz="800" b="1" kern="0" dirty="0" err="1">
                <a:effectLst/>
                <a:latin typeface="Arial" panose="020B0604020202020204" pitchFamily="34" charset="0"/>
                <a:ea typeface="SimSun" panose="02010600030101010101" pitchFamily="2" charset="-122"/>
              </a:rPr>
              <a:t>NanoString</a:t>
            </a:r>
            <a:r>
              <a:rPr lang="en-US" sz="800" b="1" kern="0" dirty="0">
                <a:effectLst/>
                <a:latin typeface="Arial" panose="020B0604020202020204" pitchFamily="34" charset="0"/>
                <a:ea typeface="SimSun" panose="02010600030101010101" pitchFamily="2" charset="-122"/>
              </a:rPr>
              <a:t> Breast Cancer 360 (BC360) Panel in treatment-naive solid tissues at diagnosis stratified by progression status. </a:t>
            </a:r>
            <a:r>
              <a:rPr lang="en-US" sz="800" kern="0" dirty="0">
                <a:effectLst/>
                <a:latin typeface="Arial" panose="020B0604020202020204" pitchFamily="34" charset="0"/>
                <a:ea typeface="SimSun" panose="02010600030101010101" pitchFamily="2" charset="-122"/>
              </a:rPr>
              <a:t> The cut-off for progression (PFS) was 3 months. Molecular subtyping, as generated using the PAM50 signature, is shown at the top of the heatmap. Expression of individual genes as well as bespoke signatures trained in breast cancers are shown (Supplementary Table 1).</a:t>
            </a:r>
            <a:endParaRPr lang="en-US" sz="800" dirty="0"/>
          </a:p>
        </p:txBody>
      </p:sp>
    </p:spTree>
    <p:extLst>
      <p:ext uri="{BB962C8B-B14F-4D97-AF65-F5344CB8AC3E}">
        <p14:creationId xmlns:p14="http://schemas.microsoft.com/office/powerpoint/2010/main" val="36214512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49</TotalTime>
  <Words>84</Words>
  <Application>Microsoft Office PowerPoint</Application>
  <PresentationFormat>Widescreen</PresentationFormat>
  <Paragraphs>3</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e Bayani</dc:creator>
  <cp:lastModifiedBy>Quann, Karen</cp:lastModifiedBy>
  <cp:revision>308</cp:revision>
  <cp:lastPrinted>2023-08-16T18:12:39Z</cp:lastPrinted>
  <dcterms:created xsi:type="dcterms:W3CDTF">2023-05-04T15:52:47Z</dcterms:created>
  <dcterms:modified xsi:type="dcterms:W3CDTF">2025-10-21T17:10:39Z</dcterms:modified>
</cp:coreProperties>
</file>